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8" r:id="rId2"/>
  </p:sldIdLst>
  <p:sldSz cx="9144000" cy="6858000" type="letter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0" autoAdjust="0"/>
    <p:restoredTop sz="94660"/>
  </p:normalViewPr>
  <p:slideViewPr>
    <p:cSldViewPr snapToGrid="0">
      <p:cViewPr varScale="1">
        <p:scale>
          <a:sx n="89" d="100"/>
          <a:sy n="89" d="100"/>
        </p:scale>
        <p:origin x="1219" y="7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6FD7AD-21C3-4626-84BE-C118DB0462D2}" type="datetimeFigureOut">
              <a:rPr lang="en-US" smtClean="0"/>
              <a:t>1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91462F-4E75-4192-AADB-DB980B3BA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3548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6FD7AD-21C3-4626-84BE-C118DB0462D2}" type="datetimeFigureOut">
              <a:rPr lang="en-US" smtClean="0"/>
              <a:t>1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91462F-4E75-4192-AADB-DB980B3BA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04744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6FD7AD-21C3-4626-84BE-C118DB0462D2}" type="datetimeFigureOut">
              <a:rPr lang="en-US" smtClean="0"/>
              <a:t>1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91462F-4E75-4192-AADB-DB980B3BA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81823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6FD7AD-21C3-4626-84BE-C118DB0462D2}" type="datetimeFigureOut">
              <a:rPr lang="en-US" smtClean="0"/>
              <a:t>1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91462F-4E75-4192-AADB-DB980B3BA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41833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6FD7AD-21C3-4626-84BE-C118DB0462D2}" type="datetimeFigureOut">
              <a:rPr lang="en-US" smtClean="0"/>
              <a:t>1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91462F-4E75-4192-AADB-DB980B3BA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25383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6FD7AD-21C3-4626-84BE-C118DB0462D2}" type="datetimeFigureOut">
              <a:rPr lang="en-US" smtClean="0"/>
              <a:t>1/19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91462F-4E75-4192-AADB-DB980B3BA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95130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6FD7AD-21C3-4626-84BE-C118DB0462D2}" type="datetimeFigureOut">
              <a:rPr lang="en-US" smtClean="0"/>
              <a:t>1/19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91462F-4E75-4192-AADB-DB980B3BA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54776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6FD7AD-21C3-4626-84BE-C118DB0462D2}" type="datetimeFigureOut">
              <a:rPr lang="en-US" smtClean="0"/>
              <a:t>1/19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91462F-4E75-4192-AADB-DB980B3BA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62510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6FD7AD-21C3-4626-84BE-C118DB0462D2}" type="datetimeFigureOut">
              <a:rPr lang="en-US" smtClean="0"/>
              <a:t>1/19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91462F-4E75-4192-AADB-DB980B3BA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97789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6FD7AD-21C3-4626-84BE-C118DB0462D2}" type="datetimeFigureOut">
              <a:rPr lang="en-US" smtClean="0"/>
              <a:t>1/19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91462F-4E75-4192-AADB-DB980B3BA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3410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6FD7AD-21C3-4626-84BE-C118DB0462D2}" type="datetimeFigureOut">
              <a:rPr lang="en-US" smtClean="0"/>
              <a:t>1/19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91462F-4E75-4192-AADB-DB980B3BA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26691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6FD7AD-21C3-4626-84BE-C118DB0462D2}" type="datetimeFigureOut">
              <a:rPr lang="en-US" smtClean="0"/>
              <a:t>1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91462F-4E75-4192-AADB-DB980B3BA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14439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91566104"/>
              </p:ext>
            </p:extLst>
          </p:nvPr>
        </p:nvGraphicFramePr>
        <p:xfrm>
          <a:off x="140629" y="86251"/>
          <a:ext cx="8862742" cy="6619353"/>
        </p:xfrm>
        <a:graphic>
          <a:graphicData uri="http://schemas.openxmlformats.org/drawingml/2006/table">
            <a:tbl>
              <a:tblPr/>
              <a:tblGrid>
                <a:gridCol w="795020"/>
                <a:gridCol w="518492"/>
                <a:gridCol w="642929"/>
                <a:gridCol w="642929"/>
                <a:gridCol w="642929"/>
                <a:gridCol w="981676"/>
                <a:gridCol w="642929"/>
                <a:gridCol w="642929"/>
                <a:gridCol w="642929"/>
                <a:gridCol w="933284"/>
                <a:gridCol w="1776696"/>
              </a:tblGrid>
              <a:tr h="25606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Determined </a:t>
                      </a:r>
                      <a:br>
                        <a:rPr lang="en-US" sz="4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</a:br>
                      <a:r>
                        <a:rPr lang="en-US" sz="4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ecretor Status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other ID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'FL</a:t>
                      </a:r>
                      <a:br>
                        <a:rPr lang="en-US" sz="4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</a:br>
                      <a:r>
                        <a:rPr lang="en-US" sz="4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(ion counts)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DFT </a:t>
                      </a:r>
                      <a:br>
                        <a:rPr lang="en-US" sz="4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</a:br>
                      <a:r>
                        <a:rPr lang="en-US" sz="4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(ion counts)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NFP I</a:t>
                      </a:r>
                      <a:br>
                        <a:rPr lang="en-US" sz="4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</a:br>
                      <a:r>
                        <a:rPr lang="en-US" sz="4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(ion counts)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FLNH III/MFLNH I</a:t>
                      </a:r>
                      <a:br>
                        <a:rPr lang="en-US" sz="4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</a:br>
                      <a:r>
                        <a:rPr lang="en-US" sz="4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(ion counts)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IFLNH I</a:t>
                      </a:r>
                      <a:br>
                        <a:rPr lang="en-US" sz="4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</a:br>
                      <a:r>
                        <a:rPr lang="en-US" sz="4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(ion counts)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DFLNH a</a:t>
                      </a:r>
                      <a:br>
                        <a:rPr lang="en-US" sz="4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</a:br>
                      <a:r>
                        <a:rPr lang="en-US" sz="4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(ion counts)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DFLNH c</a:t>
                      </a:r>
                      <a:br>
                        <a:rPr lang="en-US" sz="4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</a:br>
                      <a:r>
                        <a:rPr lang="en-US" sz="4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(ion counts)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ec Marker Sum</a:t>
                      </a:r>
                      <a:br>
                        <a:rPr lang="en-US" sz="4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</a:br>
                      <a:r>
                        <a:rPr lang="en-US" sz="4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(ion counts)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rmalized Sec Marker Sum</a:t>
                      </a:r>
                      <a:br>
                        <a:rPr lang="en-US" sz="4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</a:br>
                      <a:r>
                        <a:rPr lang="en-US" sz="4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(% of Total HMO Intensity)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9863">
                <a:tc rowSpan="12"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n-Secretor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42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38E+05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24E+04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17E+05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.50E+04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77E+05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.35E+04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59E+04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.80E+05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9</a:t>
                      </a:r>
                    </a:p>
                  </a:txBody>
                  <a:tcPr marL="4509" marR="4509" marT="450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2986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04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59E+04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27E+05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.00E+04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.41E+05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17E+04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17E+0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01E+05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77E+0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39</a:t>
                      </a:r>
                    </a:p>
                  </a:txBody>
                  <a:tcPr marL="4509" marR="4509" marT="45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986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38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30E+05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24E+04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.34E+04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74E+05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17E+04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13E+0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28E+05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11E+0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41</a:t>
                      </a:r>
                    </a:p>
                  </a:txBody>
                  <a:tcPr marL="4509" marR="4509" marT="45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986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55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28E+05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24E+04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17E+04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91E+0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17E+04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.35E+04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.48E+05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86E+0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41</a:t>
                      </a:r>
                    </a:p>
                  </a:txBody>
                  <a:tcPr marL="4509" marR="4509" marT="45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986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03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.69E+04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05E+05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17E+04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61E+0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17E+04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.35E+04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59E+04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98E+0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51</a:t>
                      </a:r>
                    </a:p>
                  </a:txBody>
                  <a:tcPr marL="4509" marR="4509" marT="45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986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4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05E+05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86E+05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.61E+04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99E+05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17E+04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64E+0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59E+04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47E+0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61</a:t>
                      </a:r>
                    </a:p>
                  </a:txBody>
                  <a:tcPr marL="4509" marR="4509" marT="45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986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01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12E+05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05E+05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12E+05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79E+0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17E+04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.27E+05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10E+05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49E+0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64</a:t>
                      </a:r>
                    </a:p>
                  </a:txBody>
                  <a:tcPr marL="4509" marR="4509" marT="45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986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23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.18E+04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09E+05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16E+05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47E+0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17E+04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.35E+04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12E+05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.17E+0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90</a:t>
                      </a:r>
                    </a:p>
                  </a:txBody>
                  <a:tcPr marL="4509" marR="4509" marT="45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986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15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27E+05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41E+05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41E+05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93E+0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17E+04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65E+0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81E+05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.26E+0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09</a:t>
                      </a:r>
                    </a:p>
                  </a:txBody>
                  <a:tcPr marL="4509" marR="4509" marT="45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986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54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.31E+04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24E+04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17E+04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86E+0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17E+04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37E+05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84E+05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.78E+0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14</a:t>
                      </a:r>
                    </a:p>
                  </a:txBody>
                  <a:tcPr marL="4509" marR="4509" marT="45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986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3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26E+05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20E+05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17E+04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.64E+05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.35E+04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21E+0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59E+04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.55E+0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26</a:t>
                      </a:r>
                    </a:p>
                  </a:txBody>
                  <a:tcPr marL="4509" marR="4509" marT="45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986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41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86E+0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.87E+0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17E+04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50E+05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17E+04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.53E+05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.17E+04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11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49</a:t>
                      </a:r>
                    </a:p>
                  </a:txBody>
                  <a:tcPr marL="4509" marR="4509" marT="45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9863">
                <a:tc rowSpan="33"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ecretor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1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35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.89E+0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67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20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79E+0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.79E+0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05E+0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.88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2.5</a:t>
                      </a:r>
                    </a:p>
                  </a:txBody>
                  <a:tcPr marL="4509" marR="4509" marT="450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2986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02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64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38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75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56E+0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25E+0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81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59E+04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.87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2.9</a:t>
                      </a:r>
                    </a:p>
                  </a:txBody>
                  <a:tcPr marL="4509" marR="4509" marT="45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986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35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91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.24E+0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56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09E+0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29E+0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.90E+05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22E+0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.15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3.4</a:t>
                      </a:r>
                    </a:p>
                  </a:txBody>
                  <a:tcPr marL="4509" marR="4509" marT="45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986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44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.06E+0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54E+0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42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45E+0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.99E+0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13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85E+0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01E+08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4.4</a:t>
                      </a:r>
                    </a:p>
                  </a:txBody>
                  <a:tcPr marL="4509" marR="4509" marT="45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986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15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15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68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55E+0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98E+05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05E+05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59E+04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.50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4.6</a:t>
                      </a:r>
                    </a:p>
                  </a:txBody>
                  <a:tcPr marL="4509" marR="4509" marT="45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986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59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76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65E+0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.29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01E+0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14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60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49E+0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25E+08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5.2</a:t>
                      </a:r>
                    </a:p>
                  </a:txBody>
                  <a:tcPr marL="4509" marR="4509" marT="45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986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40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54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.30E+0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.55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.50E+04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.60E+0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77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43E+0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28E+08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5.8</a:t>
                      </a:r>
                    </a:p>
                  </a:txBody>
                  <a:tcPr marL="4509" marR="4509" marT="45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986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19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39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36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77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.37E+05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.15E+0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15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39E+0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06E+08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6.0</a:t>
                      </a:r>
                    </a:p>
                  </a:txBody>
                  <a:tcPr marL="4509" marR="4509" marT="45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986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53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22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37E+0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94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42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54E+05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03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65E+0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35E+08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6.2</a:t>
                      </a:r>
                    </a:p>
                  </a:txBody>
                  <a:tcPr marL="4509" marR="4509" marT="45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986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29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33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24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36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47E+0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25E+0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99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55E+0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08E+08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6.8</a:t>
                      </a:r>
                    </a:p>
                  </a:txBody>
                  <a:tcPr marL="4509" marR="4509" marT="45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986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08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05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.95E+0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.72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05E+0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.83E+0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68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24E+0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37E+08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6.9</a:t>
                      </a:r>
                    </a:p>
                  </a:txBody>
                  <a:tcPr marL="4509" marR="4509" marT="45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986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28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23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.13E+0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.40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14E+0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.60E+0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65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88E+0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44E+08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7.3</a:t>
                      </a:r>
                    </a:p>
                  </a:txBody>
                  <a:tcPr marL="4509" marR="4509" marT="45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986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14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43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77E+0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01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73E+0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60E+0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55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42E+0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04E+08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7.5</a:t>
                      </a:r>
                    </a:p>
                  </a:txBody>
                  <a:tcPr marL="4509" marR="4509" marT="45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986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32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10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41E+0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62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13E+0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.20E+0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01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61E+0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11E+08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7.5</a:t>
                      </a:r>
                    </a:p>
                  </a:txBody>
                  <a:tcPr marL="4509" marR="4509" marT="45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986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65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52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29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47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.50E+04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.44E+04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27E+05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59E+04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03E+08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8.0</a:t>
                      </a:r>
                    </a:p>
                  </a:txBody>
                  <a:tcPr marL="4509" marR="4509" marT="45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986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33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30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10E+0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.14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51E+0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17E+04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51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95E+0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48E+08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8.7</a:t>
                      </a:r>
                    </a:p>
                  </a:txBody>
                  <a:tcPr marL="4509" marR="4509" marT="45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986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64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00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.25E+0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43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99E+0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86E+0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20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32E+0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23E+08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8.8</a:t>
                      </a:r>
                    </a:p>
                  </a:txBody>
                  <a:tcPr marL="4509" marR="4509" marT="45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986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09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47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.75E+0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75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13E+0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.68E+0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21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10E+0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55E+08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9.5</a:t>
                      </a:r>
                    </a:p>
                  </a:txBody>
                  <a:tcPr marL="4509" marR="4509" marT="45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986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43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12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58E+0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.19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35E+0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54E+0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59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83E+0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20E+08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9.7</a:t>
                      </a:r>
                    </a:p>
                  </a:txBody>
                  <a:tcPr marL="4509" marR="4509" marT="45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986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12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48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.14E+0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74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03E+05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21E+0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99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64E+0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13E+08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9.7</a:t>
                      </a:r>
                    </a:p>
                  </a:txBody>
                  <a:tcPr marL="4509" marR="4509" marT="45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986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60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42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21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80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.16E+05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17E+04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38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09E+0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11E+08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0.1</a:t>
                      </a:r>
                    </a:p>
                  </a:txBody>
                  <a:tcPr marL="4509" marR="4509" marT="45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986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50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70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60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49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.92E+05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13E+0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23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13E+0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36E+08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1.1</a:t>
                      </a:r>
                    </a:p>
                  </a:txBody>
                  <a:tcPr marL="4509" marR="4509" marT="45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986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11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41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80E+0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.40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01E+0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01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41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18E+0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51E+08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1.2</a:t>
                      </a:r>
                    </a:p>
                  </a:txBody>
                  <a:tcPr marL="4509" marR="4509" marT="45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986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00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02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.00E+0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49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90E+05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37E+0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72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74E+0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27E+08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1.7</a:t>
                      </a:r>
                    </a:p>
                  </a:txBody>
                  <a:tcPr marL="4509" marR="4509" marT="45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986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39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29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13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19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03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.60E+0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22E+0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73E+05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.95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2.3</a:t>
                      </a:r>
                    </a:p>
                  </a:txBody>
                  <a:tcPr marL="4509" marR="4509" marT="45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986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25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81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82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96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50E+05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75E+0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53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37E+0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28E+08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2.6</a:t>
                      </a:r>
                    </a:p>
                  </a:txBody>
                  <a:tcPr marL="4509" marR="4509" marT="45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986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13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65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33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60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60E+0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26E+0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55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75E+0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38E+08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2.7</a:t>
                      </a:r>
                    </a:p>
                  </a:txBody>
                  <a:tcPr marL="4509" marR="4509" marT="45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986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31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79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66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17E+04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26E+0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88E+05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82E+0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59E+04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.01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3.9</a:t>
                      </a:r>
                    </a:p>
                  </a:txBody>
                  <a:tcPr marL="4509" marR="4509" marT="45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986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34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63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44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08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17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.05E+0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.34E+0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03E+05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16E+08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3.9</a:t>
                      </a:r>
                    </a:p>
                  </a:txBody>
                  <a:tcPr marL="4509" marR="4509" marT="45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986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5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95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84E+0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.96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94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.37E+0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69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63E+0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31E+08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4.1</a:t>
                      </a:r>
                    </a:p>
                  </a:txBody>
                  <a:tcPr marL="4509" marR="4509" marT="45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986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3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05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78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29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97E+05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37E+0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70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34E+0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43E+08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4.4</a:t>
                      </a:r>
                    </a:p>
                  </a:txBody>
                  <a:tcPr marL="4509" marR="4509" marT="45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986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05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00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33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.99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71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51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67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61E+0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04E+08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7.3</a:t>
                      </a:r>
                    </a:p>
                  </a:txBody>
                  <a:tcPr marL="4509" marR="4509" marT="45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986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45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96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62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04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70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.27E+04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62E+0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20E+05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.51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0.0</a:t>
                      </a:r>
                    </a:p>
                  </a:txBody>
                  <a:tcPr marL="4509" marR="4509" marT="45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9863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n-Secretor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vg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60E+05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.65E+05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.04E+04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14E+0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.60E+04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17E+0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32E+05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70E+0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912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2986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tdev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07E+05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24E+0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11E+04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02E+0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04E+05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49E+0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04E+05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92E+0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88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9863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ecretor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vg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50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15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30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66E+0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78E+0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15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74E+0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23E+08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9.290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986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tdev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20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.49E+0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47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.73E+0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09E+0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43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24E+06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23E+07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180</a:t>
                      </a:r>
                    </a:p>
                  </a:txBody>
                  <a:tcPr marL="4509" marR="4509" marT="450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418421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4</TotalTime>
  <Words>518</Words>
  <Application>Microsoft Office PowerPoint</Application>
  <PresentationFormat>Letter Paper (8.5x11 in)</PresentationFormat>
  <Paragraphs>50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Zachery Lewis</dc:creator>
  <cp:lastModifiedBy>Zachery Lewis</cp:lastModifiedBy>
  <cp:revision>13</cp:revision>
  <dcterms:created xsi:type="dcterms:W3CDTF">2014-09-02T01:12:04Z</dcterms:created>
  <dcterms:modified xsi:type="dcterms:W3CDTF">2015-01-19T21:53:21Z</dcterms:modified>
</cp:coreProperties>
</file>